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51" autoAdjust="0"/>
    <p:restoredTop sz="94660"/>
  </p:normalViewPr>
  <p:slideViewPr>
    <p:cSldViewPr snapToGrid="0">
      <p:cViewPr varScale="1">
        <p:scale>
          <a:sx n="52" d="100"/>
          <a:sy n="52" d="100"/>
        </p:scale>
        <p:origin x="2846" y="5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420531-DA3E-4CCA-9A44-283DD99BED7B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73D3CD-4A5D-4542-8C6A-9903B16336D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4454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73D3CD-4A5D-4542-8C6A-9903B16336D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53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5285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7624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2071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474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3725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92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9760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0384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2300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8026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8503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EC2E6-7A00-4F29-8E96-99BCA1C72946}" type="datetimeFigureOut">
              <a:rPr lang="es-ES" smtClean="0"/>
              <a:t>04/11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B21ED-1D3D-425F-BA5D-557F0527000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357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19EC7037-D920-B9FD-5276-AC21A8D3A882}"/>
              </a:ext>
            </a:extLst>
          </p:cNvPr>
          <p:cNvSpPr txBox="1"/>
          <p:nvPr/>
        </p:nvSpPr>
        <p:spPr>
          <a:xfrm>
            <a:off x="472575" y="379725"/>
            <a:ext cx="5965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D4+ Th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in PBMCs from study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Imagen 38">
            <a:extLst>
              <a:ext uri="{FF2B5EF4-FFF2-40B4-BE49-F238E27FC236}">
                <a16:creationId xmlns:a16="http://schemas.microsoft.com/office/drawing/2014/main" id="{1F0063A0-655F-0E9B-45F9-7801492A0C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624584"/>
            <a:ext cx="6858000" cy="6656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7406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</TotalTime>
  <Words>25</Words>
  <Application>Microsoft Office PowerPoint</Application>
  <PresentationFormat>A4 (210 x 297 mm)</PresentationFormat>
  <Paragraphs>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anchez</dc:creator>
  <cp:lastModifiedBy>MARIA TERESA COIRAS LOPEZ</cp:lastModifiedBy>
  <cp:revision>31</cp:revision>
  <cp:lastPrinted>2024-02-23T10:58:54Z</cp:lastPrinted>
  <dcterms:created xsi:type="dcterms:W3CDTF">2022-05-04T10:38:35Z</dcterms:created>
  <dcterms:modified xsi:type="dcterms:W3CDTF">2025-11-04T06:09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0-30T20:54:16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659297fd-d0c3-48bc-8663-53d5a1875a4c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